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>
        <p:scale>
          <a:sx n="109" d="100"/>
          <a:sy n="109" d="100"/>
        </p:scale>
        <p:origin x="-72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AADE63-3F0B-F14C-8C6C-8D65B914E47B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AB543B-36B3-1142-AD7E-895FC094E91E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411024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AB543B-36B3-1142-AD7E-895FC094E91E}" type="slidenum">
              <a:rPr lang="en-IT" smtClean="0"/>
              <a:t>1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3213461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462F5-55AF-70A3-8957-B4AC40F210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8847B4-D19B-9AB4-82F9-C1E7164B7B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77DDE6-BC91-FD86-6E0F-59AF784FF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46CB73-9CCF-6C55-6B71-A36D3211C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7CA622-EE5D-A879-C489-F25E97B85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022043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849C91-C529-C7FB-E056-A0E0FB78AB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8F5672-E4A3-F6CC-104F-986E7379D5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1A9CD5-0E47-1E6B-EFB7-B81A8318E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D7DF77-1C34-E80A-5E6F-C0DCFDFF4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74D899-D078-BB35-DCA6-D45019399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318287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20ABD61-BA49-ECFD-D991-63D33A815A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3CB4AF-DA65-419B-49FB-8A36A5ECE4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03F73A-F605-C2CD-39DA-4321EB0DE9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B38CA0-7956-0BF1-7B5B-094154276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BAFDC3-F4F2-B6E4-50D9-ED067B5BB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593583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6486A3-D142-58F7-D080-7940AC913B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BCEF93-8B11-E9BE-A9FA-1B0B6EE1F1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3B20A2-105F-D1F8-7FA3-69D6F960CB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1D043-787A-56D8-EEDE-F08E09DCA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ECFA32-962C-3090-F03C-75F063028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704399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A8A971-9AC0-BC3E-4BAB-A094CB85B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0597BB-597A-0653-2CE8-C494D59E81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A4854B-F0C8-CE15-BEB8-3EE382F76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FD5DCC-CCE2-C6EF-5539-6C5290A10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491235-F6D1-1FF1-6E61-2C018C693F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467520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768071-9CE7-10C7-2B5D-EB75F0C30F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47BF8E-86B2-7B72-F56C-B3AD878C2B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0BDD7E-566A-232A-C325-C24D4040E4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00511D-5EF0-E357-9853-EFF54419B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F22F10-E5AB-A284-56FB-DA133B508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F8E6BA-F266-052A-78E4-E6A5FA398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132787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D4F9C1-2DFA-9ABE-3025-43158E60E7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34695B-32E9-1167-5531-53496FC107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9319C8-97F0-5BE2-89B4-DA7B5C1040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40FFA45-C974-BC93-9BCF-FB762479DB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EFF1BE-E6C6-2D85-5EE5-CF138F11CC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B494C4-A9CE-4BBA-0812-661FA87E0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0313ADC-0AF3-6AC3-C095-F7E94372C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3E3574-66A0-2562-9EC8-2C26A4DF6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4571164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A00D41-5A72-0D85-4EBB-AEC3A9A5EA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BE6D37-D093-B394-3B76-AF70E4377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F89C59-155C-20E4-C6F0-C3BF12EFA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F048440-5B9D-E891-2EE2-A623750EE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752227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C30FDD-4898-C8CF-1C35-CA33A4BDA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E9A784B-A865-DFF2-2FA4-29B180983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10E232-4F95-D877-2BCA-86654A0DA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901811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8FC9A2-C021-3D39-7DB5-97C4A22602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3D86CB-9AA2-5B9B-3E0E-4C8F2E3A276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29AD02-3519-9804-B81B-6595C2847D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3D8807-7AB7-2EE0-F43B-F94938FE7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46E97E-4E56-34F4-18FE-02844AD98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024DDF-12F8-8842-6088-4A204ADE2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305095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966687-CF95-5E22-83D4-EACA0724E1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BAA616-B07F-76F3-8A20-6F72DB1A74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72783F-9155-5BBF-BFC3-57C0E82BD3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2452F3-FB42-0A76-44E8-559B05CFB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7AECE3-C46A-AFBA-11C6-27B5F15BE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031A76-607D-9738-B1F2-AF32C86F1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4126500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8B15FD-519C-C8B5-57A2-269BD15DCF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B90981-3931-A803-391A-F5B8ACD2EA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4332D2-A53D-5D5D-D31C-61276E7BC4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22D2FF-782B-B34D-B49C-CBCBEC60FAE0}" type="datetimeFigureOut">
              <a:rPr lang="en-IT" smtClean="0"/>
              <a:t>04/01/23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F74ED-B52E-CDD9-159A-73F094420B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DB935D-115D-FFAC-5046-BD01EDF3A7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FBF337-B0E3-9847-B308-97D9B7037C25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856332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153EECC-045E-42EE-1722-E0A6A48CDE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96722" y="1401999"/>
            <a:ext cx="2804983" cy="1925810"/>
          </a:xfrm>
          <a:prstGeom prst="rect">
            <a:avLst/>
          </a:prstGeom>
          <a:ln>
            <a:noFill/>
          </a:ln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B442B3BA-982D-16F3-8D7F-10DB53669BDD}"/>
              </a:ext>
            </a:extLst>
          </p:cNvPr>
          <p:cNvCxnSpPr>
            <a:cxnSpLocks/>
          </p:cNvCxnSpPr>
          <p:nvPr/>
        </p:nvCxnSpPr>
        <p:spPr>
          <a:xfrm>
            <a:off x="2614844" y="2854739"/>
            <a:ext cx="3089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3086121-27B5-F5F4-3753-11AE0AE73C5B}"/>
              </a:ext>
            </a:extLst>
          </p:cNvPr>
          <p:cNvCxnSpPr>
            <a:cxnSpLocks/>
          </p:cNvCxnSpPr>
          <p:nvPr/>
        </p:nvCxnSpPr>
        <p:spPr>
          <a:xfrm>
            <a:off x="2614844" y="3122753"/>
            <a:ext cx="3089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745EDB0F-0BB3-D486-8A36-D4293B122CB5}"/>
              </a:ext>
            </a:extLst>
          </p:cNvPr>
          <p:cNvCxnSpPr>
            <a:cxnSpLocks/>
          </p:cNvCxnSpPr>
          <p:nvPr/>
        </p:nvCxnSpPr>
        <p:spPr>
          <a:xfrm>
            <a:off x="2614844" y="2423815"/>
            <a:ext cx="3089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15413D60-CCE6-D2ED-C215-5A82874365B6}"/>
              </a:ext>
            </a:extLst>
          </p:cNvPr>
          <p:cNvSpPr txBox="1"/>
          <p:nvPr/>
        </p:nvSpPr>
        <p:spPr>
          <a:xfrm>
            <a:off x="2208592" y="2668536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7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8706976-94E8-466D-70FE-918CBE486FC0}"/>
              </a:ext>
            </a:extLst>
          </p:cNvPr>
          <p:cNvSpPr txBox="1"/>
          <p:nvPr/>
        </p:nvSpPr>
        <p:spPr>
          <a:xfrm>
            <a:off x="2208592" y="2968146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5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26630EB-3FD1-75D0-41CB-2E128DE8F1EC}"/>
              </a:ext>
            </a:extLst>
          </p:cNvPr>
          <p:cNvSpPr txBox="1"/>
          <p:nvPr/>
        </p:nvSpPr>
        <p:spPr>
          <a:xfrm>
            <a:off x="2208592" y="2257929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95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2792047-6F4A-1B47-2FD6-879F55541747}"/>
              </a:ext>
            </a:extLst>
          </p:cNvPr>
          <p:cNvSpPr/>
          <p:nvPr/>
        </p:nvSpPr>
        <p:spPr>
          <a:xfrm>
            <a:off x="3377947" y="2624321"/>
            <a:ext cx="766838" cy="402440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CF9428D-D056-ABE8-F0C3-197E70509A9E}"/>
              </a:ext>
            </a:extLst>
          </p:cNvPr>
          <p:cNvSpPr txBox="1"/>
          <p:nvPr/>
        </p:nvSpPr>
        <p:spPr>
          <a:xfrm rot="18568641">
            <a:off x="2840390" y="731129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N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EF3BFEA-8E74-F3EA-EB5E-56CB0948682E}"/>
              </a:ext>
            </a:extLst>
          </p:cNvPr>
          <p:cNvSpPr txBox="1"/>
          <p:nvPr/>
        </p:nvSpPr>
        <p:spPr>
          <a:xfrm rot="18568641">
            <a:off x="3258116" y="744743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shLU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4982BC8-BFB5-E5AB-D37D-08AE04293781}"/>
              </a:ext>
            </a:extLst>
          </p:cNvPr>
          <p:cNvSpPr txBox="1"/>
          <p:nvPr/>
        </p:nvSpPr>
        <p:spPr>
          <a:xfrm>
            <a:off x="2161844" y="1101832"/>
            <a:ext cx="773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F41B74C-E8B6-522B-993E-763BDF5C8E7E}"/>
              </a:ext>
            </a:extLst>
          </p:cNvPr>
          <p:cNvSpPr txBox="1"/>
          <p:nvPr/>
        </p:nvSpPr>
        <p:spPr>
          <a:xfrm>
            <a:off x="4769695" y="2657429"/>
            <a:ext cx="776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b="1" dirty="0">
                <a:solidFill>
                  <a:srgbClr val="FF0000"/>
                </a:solidFill>
              </a:rPr>
              <a:t>TFE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DAE028B-C152-31B9-2A01-0C98A83470DD}"/>
              </a:ext>
            </a:extLst>
          </p:cNvPr>
          <p:cNvSpPr txBox="1"/>
          <p:nvPr/>
        </p:nvSpPr>
        <p:spPr>
          <a:xfrm rot="18568641">
            <a:off x="3637220" y="744742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shTFEB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AD97AD9-291B-A46F-35E7-2BFEE42E6626}"/>
              </a:ext>
            </a:extLst>
          </p:cNvPr>
          <p:cNvSpPr txBox="1"/>
          <p:nvPr/>
        </p:nvSpPr>
        <p:spPr>
          <a:xfrm>
            <a:off x="1417297" y="8557380"/>
            <a:ext cx="773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kDa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5B195F22-C39A-2C5F-0F6C-5A8FF2BD0532}"/>
              </a:ext>
            </a:extLst>
          </p:cNvPr>
          <p:cNvGrpSpPr/>
          <p:nvPr/>
        </p:nvGrpSpPr>
        <p:grpSpPr>
          <a:xfrm>
            <a:off x="1996722" y="3595822"/>
            <a:ext cx="3638351" cy="1875792"/>
            <a:chOff x="877441" y="3857244"/>
            <a:chExt cx="3638351" cy="1875792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090789C6-2F16-F43E-9E0D-B1C3DBEE93B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77441" y="5165646"/>
              <a:ext cx="2695099" cy="567390"/>
            </a:xfrm>
            <a:prstGeom prst="rect">
              <a:avLst/>
            </a:prstGeom>
            <a:ln>
              <a:noFill/>
            </a:ln>
          </p:spPr>
        </p:pic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ED306281-A7EB-6057-665A-C3073F79AFDF}"/>
                </a:ext>
              </a:extLst>
            </p:cNvPr>
            <p:cNvCxnSpPr>
              <a:cxnSpLocks/>
            </p:cNvCxnSpPr>
            <p:nvPr/>
          </p:nvCxnSpPr>
          <p:spPr>
            <a:xfrm>
              <a:off x="1643536" y="5465432"/>
              <a:ext cx="30891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6D5D145-927B-F332-B5B2-6DCECA61D7DB}"/>
                </a:ext>
              </a:extLst>
            </p:cNvPr>
            <p:cNvSpPr txBox="1"/>
            <p:nvPr/>
          </p:nvSpPr>
          <p:spPr>
            <a:xfrm>
              <a:off x="1237284" y="5279229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T" sz="1400" dirty="0"/>
                <a:t>4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7654088-60B5-4DF9-16BE-8AEC30DED5DD}"/>
                </a:ext>
              </a:extLst>
            </p:cNvPr>
            <p:cNvSpPr txBox="1"/>
            <p:nvPr/>
          </p:nvSpPr>
          <p:spPr>
            <a:xfrm>
              <a:off x="1174079" y="4845043"/>
              <a:ext cx="7737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T" sz="1400" dirty="0"/>
                <a:t>kD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9ED3414-A110-788A-BFA9-A9F93F0F2ABD}"/>
                </a:ext>
              </a:extLst>
            </p:cNvPr>
            <p:cNvSpPr txBox="1"/>
            <p:nvPr/>
          </p:nvSpPr>
          <p:spPr>
            <a:xfrm rot="18568641">
              <a:off x="2018116" y="4437855"/>
              <a:ext cx="14247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T" sz="1200" b="1" dirty="0"/>
                <a:t>UOK257-N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CEC6FF5-74E2-C667-C7C8-B6C4B6979B69}"/>
                </a:ext>
              </a:extLst>
            </p:cNvPr>
            <p:cNvSpPr txBox="1"/>
            <p:nvPr/>
          </p:nvSpPr>
          <p:spPr>
            <a:xfrm rot="18568641">
              <a:off x="2370587" y="4431126"/>
              <a:ext cx="14247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T" sz="1200" b="1" dirty="0"/>
                <a:t>UOK257-shLUC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5569501-9361-B9F2-F685-503D62B11100}"/>
                </a:ext>
              </a:extLst>
            </p:cNvPr>
            <p:cNvSpPr txBox="1"/>
            <p:nvPr/>
          </p:nvSpPr>
          <p:spPr>
            <a:xfrm rot="18568641">
              <a:off x="2687186" y="4444739"/>
              <a:ext cx="14247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T" sz="1200" b="1" dirty="0"/>
                <a:t>UOK257-shTFEB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6051F412-62BE-F45A-2DD2-C98B6F71E703}"/>
                </a:ext>
              </a:extLst>
            </p:cNvPr>
            <p:cNvSpPr/>
            <p:nvPr/>
          </p:nvSpPr>
          <p:spPr>
            <a:xfrm>
              <a:off x="2506500" y="5184566"/>
              <a:ext cx="766838" cy="307774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T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AA5088B-90A1-FAD0-C58C-7CB51055EC6E}"/>
                </a:ext>
              </a:extLst>
            </p:cNvPr>
            <p:cNvSpPr txBox="1"/>
            <p:nvPr/>
          </p:nvSpPr>
          <p:spPr>
            <a:xfrm>
              <a:off x="3739616" y="5228047"/>
              <a:ext cx="7761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T" b="1" dirty="0">
                  <a:solidFill>
                    <a:srgbClr val="FF0000"/>
                  </a:solidFill>
                </a:rPr>
                <a:t>ACTIN</a:t>
              </a:r>
            </a:p>
          </p:txBody>
        </p:sp>
      </p:grpSp>
      <p:pic>
        <p:nvPicPr>
          <p:cNvPr id="38" name="Picture 37">
            <a:extLst>
              <a:ext uri="{FF2B5EF4-FFF2-40B4-BE49-F238E27FC236}">
                <a16:creationId xmlns:a16="http://schemas.microsoft.com/office/drawing/2014/main" id="{1C1FC978-7C3F-A238-916F-23B1D798F6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42858" y="1271659"/>
            <a:ext cx="2333012" cy="2055273"/>
          </a:xfrm>
          <a:prstGeom prst="rect">
            <a:avLst/>
          </a:prstGeom>
          <a:ln>
            <a:noFill/>
          </a:ln>
        </p:spPr>
      </p:pic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E052FDFC-3FC4-546E-0C7F-1903B20BE9C3}"/>
              </a:ext>
            </a:extLst>
          </p:cNvPr>
          <p:cNvCxnSpPr>
            <a:cxnSpLocks/>
          </p:cNvCxnSpPr>
          <p:nvPr/>
        </p:nvCxnSpPr>
        <p:spPr>
          <a:xfrm>
            <a:off x="7572156" y="2426023"/>
            <a:ext cx="3089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60AED35C-AD8A-EE62-F0AC-03D0687C5C2E}"/>
              </a:ext>
            </a:extLst>
          </p:cNvPr>
          <p:cNvCxnSpPr>
            <a:cxnSpLocks/>
          </p:cNvCxnSpPr>
          <p:nvPr/>
        </p:nvCxnSpPr>
        <p:spPr>
          <a:xfrm>
            <a:off x="7572156" y="2795637"/>
            <a:ext cx="3089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DB977DD5-967C-D6E6-637E-FBB2AF6E8706}"/>
              </a:ext>
            </a:extLst>
          </p:cNvPr>
          <p:cNvCxnSpPr>
            <a:cxnSpLocks/>
          </p:cNvCxnSpPr>
          <p:nvPr/>
        </p:nvCxnSpPr>
        <p:spPr>
          <a:xfrm>
            <a:off x="7572156" y="2066219"/>
            <a:ext cx="3089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3D2F05A3-6279-3E40-BCAF-A8602A711EE7}"/>
              </a:ext>
            </a:extLst>
          </p:cNvPr>
          <p:cNvSpPr txBox="1"/>
          <p:nvPr/>
        </p:nvSpPr>
        <p:spPr>
          <a:xfrm>
            <a:off x="7165904" y="2239820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7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0B1C111-6329-F8E9-8C76-1FD06B3D59D1}"/>
              </a:ext>
            </a:extLst>
          </p:cNvPr>
          <p:cNvSpPr txBox="1"/>
          <p:nvPr/>
        </p:nvSpPr>
        <p:spPr>
          <a:xfrm>
            <a:off x="7165904" y="2641030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5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0875A6E-A196-F80D-1594-35EE9C495128}"/>
              </a:ext>
            </a:extLst>
          </p:cNvPr>
          <p:cNvSpPr txBox="1"/>
          <p:nvPr/>
        </p:nvSpPr>
        <p:spPr>
          <a:xfrm>
            <a:off x="7165904" y="1900333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9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C4212E9-4BC1-EE8F-9E85-CE6F5ED2989A}"/>
              </a:ext>
            </a:extLst>
          </p:cNvPr>
          <p:cNvSpPr txBox="1"/>
          <p:nvPr/>
        </p:nvSpPr>
        <p:spPr>
          <a:xfrm rot="18568641">
            <a:off x="7742116" y="548509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N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59A72FC-CEE7-EEC3-C872-F4B293BC1F26}"/>
              </a:ext>
            </a:extLst>
          </p:cNvPr>
          <p:cNvSpPr txBox="1"/>
          <p:nvPr/>
        </p:nvSpPr>
        <p:spPr>
          <a:xfrm rot="18568641">
            <a:off x="8159842" y="562123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shLUC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09B571C-0D14-6530-4729-F31C16B955E6}"/>
              </a:ext>
            </a:extLst>
          </p:cNvPr>
          <p:cNvSpPr txBox="1"/>
          <p:nvPr/>
        </p:nvSpPr>
        <p:spPr>
          <a:xfrm>
            <a:off x="7490290" y="919212"/>
            <a:ext cx="773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kD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276C7ED-F130-6676-4864-0301ECE6C546}"/>
              </a:ext>
            </a:extLst>
          </p:cNvPr>
          <p:cNvSpPr txBox="1"/>
          <p:nvPr/>
        </p:nvSpPr>
        <p:spPr>
          <a:xfrm rot="18568641">
            <a:off x="8589746" y="562122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shTFE3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AAA63A26-0FF6-D3AC-7E50-05177210460C}"/>
              </a:ext>
            </a:extLst>
          </p:cNvPr>
          <p:cNvSpPr/>
          <p:nvPr/>
        </p:nvSpPr>
        <p:spPr>
          <a:xfrm>
            <a:off x="8342789" y="2426022"/>
            <a:ext cx="900348" cy="487327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27278B8-3B3C-5ACE-CFBD-4C77283DC81E}"/>
              </a:ext>
            </a:extLst>
          </p:cNvPr>
          <p:cNvSpPr txBox="1"/>
          <p:nvPr/>
        </p:nvSpPr>
        <p:spPr>
          <a:xfrm>
            <a:off x="9858115" y="2485019"/>
            <a:ext cx="776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b="1" dirty="0">
                <a:solidFill>
                  <a:srgbClr val="FF0000"/>
                </a:solidFill>
              </a:rPr>
              <a:t>TFE3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003242CB-2940-5C74-EA9A-B19C8BB3BF1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83942" y="4714189"/>
            <a:ext cx="2486960" cy="756901"/>
          </a:xfrm>
          <a:prstGeom prst="rect">
            <a:avLst/>
          </a:prstGeom>
          <a:ln>
            <a:noFill/>
          </a:ln>
        </p:spPr>
      </p:pic>
      <p:sp>
        <p:nvSpPr>
          <p:cNvPr id="52" name="Rectangle 51">
            <a:extLst>
              <a:ext uri="{FF2B5EF4-FFF2-40B4-BE49-F238E27FC236}">
                <a16:creationId xmlns:a16="http://schemas.microsoft.com/office/drawing/2014/main" id="{348ED3BF-FEA4-6DAD-A56E-BD67103A95F1}"/>
              </a:ext>
            </a:extLst>
          </p:cNvPr>
          <p:cNvSpPr/>
          <p:nvPr/>
        </p:nvSpPr>
        <p:spPr>
          <a:xfrm>
            <a:off x="8422049" y="4806844"/>
            <a:ext cx="900348" cy="294937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82F4F5C-47EE-2AED-131A-C8DC83E33BA8}"/>
              </a:ext>
            </a:extLst>
          </p:cNvPr>
          <p:cNvSpPr txBox="1"/>
          <p:nvPr/>
        </p:nvSpPr>
        <p:spPr>
          <a:xfrm>
            <a:off x="9875870" y="4806844"/>
            <a:ext cx="776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b="1" dirty="0">
                <a:solidFill>
                  <a:srgbClr val="FF0000"/>
                </a:solidFill>
              </a:rPr>
              <a:t>ACTIN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EE86AA6-0E0E-1C70-D18D-FD26055744F8}"/>
              </a:ext>
            </a:extLst>
          </p:cNvPr>
          <p:cNvCxnSpPr>
            <a:cxnSpLocks/>
          </p:cNvCxnSpPr>
          <p:nvPr/>
        </p:nvCxnSpPr>
        <p:spPr>
          <a:xfrm>
            <a:off x="7601922" y="5026801"/>
            <a:ext cx="3089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56E5E47F-EAB0-67CE-E3A2-C5FE7BC40D19}"/>
              </a:ext>
            </a:extLst>
          </p:cNvPr>
          <p:cNvSpPr txBox="1"/>
          <p:nvPr/>
        </p:nvSpPr>
        <p:spPr>
          <a:xfrm>
            <a:off x="7195670" y="4840598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43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3C28FC8-A816-7734-9C8A-48CC357BFF01}"/>
              </a:ext>
            </a:extLst>
          </p:cNvPr>
          <p:cNvSpPr txBox="1"/>
          <p:nvPr/>
        </p:nvSpPr>
        <p:spPr>
          <a:xfrm>
            <a:off x="7507780" y="4496661"/>
            <a:ext cx="773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kD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385C0CD-1E53-10A0-3ECA-05F959A54413}"/>
              </a:ext>
            </a:extLst>
          </p:cNvPr>
          <p:cNvSpPr txBox="1"/>
          <p:nvPr/>
        </p:nvSpPr>
        <p:spPr>
          <a:xfrm rot="18568641">
            <a:off x="7886285" y="4024356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N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9A7EF4A-8929-E1F1-D2B1-2DFFA94C8B24}"/>
              </a:ext>
            </a:extLst>
          </p:cNvPr>
          <p:cNvSpPr txBox="1"/>
          <p:nvPr/>
        </p:nvSpPr>
        <p:spPr>
          <a:xfrm rot="18568641">
            <a:off x="8304011" y="4037970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shLUC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356AAD3-F3A9-EF2D-2119-571DF9D46242}"/>
              </a:ext>
            </a:extLst>
          </p:cNvPr>
          <p:cNvSpPr txBox="1"/>
          <p:nvPr/>
        </p:nvSpPr>
        <p:spPr>
          <a:xfrm rot="18568641">
            <a:off x="8733915" y="4037969"/>
            <a:ext cx="14247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b="1" dirty="0"/>
              <a:t>UOK257-shTFE3</a:t>
            </a:r>
          </a:p>
        </p:txBody>
      </p:sp>
    </p:spTree>
    <p:extLst>
      <p:ext uri="{BB962C8B-B14F-4D97-AF65-F5344CB8AC3E}">
        <p14:creationId xmlns:p14="http://schemas.microsoft.com/office/powerpoint/2010/main" val="1179170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30</Words>
  <Application>Microsoft Macintosh PowerPoint</Application>
  <PresentationFormat>Widescreen</PresentationFormat>
  <Paragraphs>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RA DI MALTA</dc:creator>
  <cp:lastModifiedBy>CHIARA DI MALTA</cp:lastModifiedBy>
  <cp:revision>5</cp:revision>
  <dcterms:created xsi:type="dcterms:W3CDTF">2023-01-04T13:56:53Z</dcterms:created>
  <dcterms:modified xsi:type="dcterms:W3CDTF">2023-01-04T14:42:07Z</dcterms:modified>
</cp:coreProperties>
</file>